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1" d="100"/>
          <a:sy n="61" d="100"/>
        </p:scale>
        <p:origin x="-1504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7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notesMaster" Target="notesMasters/notesMaster1.xml"/><Relationship Id="rId6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4CE36F-A471-4046-BE81-55284314337D}" type="datetimeFigureOut">
              <a:rPr lang="en-US" smtClean="0"/>
              <a:t>6/21/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EDEB04-7F49-8640-81D1-84D5B325A5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5595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457175">
              <a:spcBef>
                <a:spcPct val="0"/>
              </a:spcBef>
              <a:defRPr/>
            </a:pPr>
            <a:endParaRPr lang="en-US" b="1" dirty="0" smtClean="0">
              <a:latin typeface="Times New Roman" charset="0"/>
              <a:ea typeface="ＭＳ Ｐゴシック" charset="0"/>
              <a:cs typeface="Times New Roman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03869B-339B-E041-BC2E-DDA03F490A9C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0254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660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932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669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6595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157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810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727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615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34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650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549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42D205-A614-A14A-AC7A-83DB9F0FEF39}" type="datetimeFigureOut">
              <a:rPr lang="en-US" smtClean="0"/>
              <a:t>6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63A19-AE1A-6A46-AA8E-BE501427F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931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312" y="265718"/>
            <a:ext cx="8770688" cy="6187359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PthAw1 (18.5 repeats)</a:t>
            </a:r>
          </a:p>
          <a:p>
            <a:pPr marL="0" indent="0">
              <a:buNone/>
            </a:pP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	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		 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NI-NG-NI-NI-HD-NI-HD-HD-HD-NG-HD-NS-NI-HD-NI-NG-NI-NS-NG</a:t>
            </a:r>
          </a:p>
          <a:p>
            <a:pPr marL="0" indent="0">
              <a:buNone/>
            </a:pP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Code	     T  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A   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T    A 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A 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C  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A    C  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C     C  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T 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C    A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   A  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C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A    T 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 A  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   T </a:t>
            </a:r>
          </a:p>
          <a:p>
            <a:pPr marL="0" indent="0">
              <a:buNone/>
            </a:pP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														               </a:t>
            </a:r>
          </a:p>
          <a:p>
            <a:pPr marL="0" indent="0">
              <a:buNone/>
            </a:pP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PthAw2 (17.5 repeats) </a:t>
            </a:r>
          </a:p>
          <a:p>
            <a:pPr marL="0" indent="0">
              <a:buNone/>
            </a:pP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			   NI-NG-NG-NG-NS-HD-HD-NS-HD-NG-NG-NG-NG-NS-HD-HD-NG-NG</a:t>
            </a:r>
          </a:p>
          <a:p>
            <a:pPr marL="0" indent="0">
              <a:buNone/>
            </a:pP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Code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	  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T    A    T     T    T   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A  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C     C   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A  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C    T     T     T     T   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A   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C     C     T     T</a:t>
            </a:r>
          </a:p>
          <a:p>
            <a:pPr marL="0" indent="0">
              <a:buNone/>
            </a:pPr>
            <a:endParaRPr lang="en-US" sz="1800" dirty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sz="1800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PthA1 (16.5 repeats)		TATATACCCACACACCCT</a:t>
            </a:r>
          </a:p>
          <a:p>
            <a:pPr marL="0" indent="0">
              <a:buNone/>
            </a:pP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PthA2 (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15.5 repeats)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		TACACACCTCTTTTAAT</a:t>
            </a:r>
          </a:p>
          <a:p>
            <a:pPr marL="0" indent="0">
              <a:buNone/>
            </a:pP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PthA3 (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15.5 repeats)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	 	TACACATCTTTAAAACT</a:t>
            </a:r>
          </a:p>
          <a:p>
            <a:pPr marL="0" indent="0">
              <a:buNone/>
            </a:pP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PthA4 (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17.5 repeats)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	</a:t>
            </a:r>
            <a:r>
              <a:rPr lang="en-US" sz="1800" smtClean="0">
                <a:latin typeface="Times New Roman" pitchFamily="18" charset="0"/>
                <a:cs typeface="Times New Roman" pitchFamily="18" charset="0"/>
              </a:rPr>
              <a:t>	TAT</a:t>
            </a:r>
            <a:r>
              <a:rPr lang="en-US" sz="180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AACCTCTTTTGCCTT</a:t>
            </a:r>
            <a:endParaRPr lang="en-US" sz="18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sz="1800" dirty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sz="18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PthAw2 		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T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A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T T T A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C C A C T T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T T A C C T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T</a:t>
            </a:r>
          </a:p>
          <a:p>
            <a:pPr marL="0" indent="0">
              <a:buNone/>
            </a:pP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                      </a:t>
            </a:r>
            <a:r>
              <a:rPr lang="en-US" sz="18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 |  |   |         |   |   |      |   |  |   |  |       |   |  |   |  </a:t>
            </a:r>
            <a:endParaRPr lang="en-US" sz="18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PthA4		T A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T A A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A C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C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T C T T T T G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800" dirty="0">
                <a:latin typeface="Times New Roman" pitchFamily="18" charset="0"/>
                <a:cs typeface="Times New Roman" pitchFamily="18" charset="0"/>
              </a:rPr>
              <a:t>C C T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T</a:t>
            </a:r>
            <a:endParaRPr lang="en-US" sz="1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96060" y="187566"/>
            <a:ext cx="377026" cy="5509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A</a:t>
            </a:r>
          </a:p>
          <a:p>
            <a:endParaRPr lang="en-US" sz="2400" b="1" dirty="0"/>
          </a:p>
          <a:p>
            <a:endParaRPr lang="en-US" sz="2400" b="1" dirty="0" smtClean="0"/>
          </a:p>
          <a:p>
            <a:endParaRPr lang="en-US" sz="2400" b="1" dirty="0"/>
          </a:p>
          <a:p>
            <a:endParaRPr lang="en-US" sz="2400" b="1" dirty="0" smtClean="0"/>
          </a:p>
          <a:p>
            <a:endParaRPr lang="en-US" sz="2400" b="1" dirty="0" smtClean="0"/>
          </a:p>
          <a:p>
            <a:endParaRPr lang="en-US" sz="3200" b="1" dirty="0"/>
          </a:p>
          <a:p>
            <a:endParaRPr lang="en-US" sz="2400" b="1" dirty="0"/>
          </a:p>
          <a:p>
            <a:r>
              <a:rPr lang="en-US" sz="2400" b="1" dirty="0" smtClean="0"/>
              <a:t>B</a:t>
            </a:r>
          </a:p>
          <a:p>
            <a:endParaRPr lang="en-US" sz="2400" b="1" dirty="0" smtClean="0"/>
          </a:p>
          <a:p>
            <a:endParaRPr lang="en-US" sz="2400" b="1" dirty="0" smtClean="0"/>
          </a:p>
          <a:p>
            <a:endParaRPr lang="en-US" sz="2400" b="1" dirty="0"/>
          </a:p>
          <a:p>
            <a:endParaRPr lang="en-US" sz="1200" b="1" dirty="0" smtClean="0"/>
          </a:p>
          <a:p>
            <a:endParaRPr lang="en-US" sz="2000" b="1" dirty="0" smtClean="0"/>
          </a:p>
          <a:p>
            <a:r>
              <a:rPr lang="en-US" sz="2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5068083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9</Words>
  <Application>Microsoft Macintosh PowerPoint</Application>
  <PresentationFormat>On-screen Show (4:3)</PresentationFormat>
  <Paragraphs>3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Florid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ha Jalan</dc:creator>
  <cp:lastModifiedBy>Neha Jalan</cp:lastModifiedBy>
  <cp:revision>1</cp:revision>
  <dcterms:created xsi:type="dcterms:W3CDTF">2013-06-21T19:53:33Z</dcterms:created>
  <dcterms:modified xsi:type="dcterms:W3CDTF">2013-06-21T19:56:58Z</dcterms:modified>
</cp:coreProperties>
</file>